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1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D77AC5D0-3F9F-45A8-BBBC-89D198384D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Υπότιτλος 2">
            <a:extLst>
              <a:ext uri="{FF2B5EF4-FFF2-40B4-BE49-F238E27FC236}">
                <a16:creationId xmlns:a16="http://schemas.microsoft.com/office/drawing/2014/main" id="{76D71C79-766A-4118-9786-EA4213804F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/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F365459F-ADA3-4A5A-BA90-5D9438348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9D2E07DC-0337-44AE-AFBE-0AB5FF508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A3300942-ACF1-408D-9714-F308359119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859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6D9328D2-BC69-48C3-907E-41E1ABE01B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A161E8BA-F46B-4B1C-A5CA-8858318228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/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54C99C36-6ECC-4148-AC9F-36C584A89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117E0B4C-A7DF-4F1A-AF0A-866498133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0B40D060-93C0-456F-BE3B-9ECE0AC06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408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>
            <a:extLst>
              <a:ext uri="{FF2B5EF4-FFF2-40B4-BE49-F238E27FC236}">
                <a16:creationId xmlns:a16="http://schemas.microsoft.com/office/drawing/2014/main" id="{C4651A9D-B101-44E9-921A-A5E53D4AA1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709D6924-3F86-421C-AC20-A24289D505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/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324B8899-188B-46BC-A2AB-02ECD84D4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66B2FE7C-B556-4C33-AAAE-68E2B2AF4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74B2A171-21AD-4441-BF8C-7E0834BE8E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11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975ACA0C-99B6-494F-97BC-3F07227AB3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A8586EED-97B9-4FDB-873A-AFCA261711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/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0892914-2EE7-4B2F-9DE1-7212E7F6D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DED06A3C-2F18-4403-B380-5D0A1E0EB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81DEF3C4-8D96-43DE-A1A4-CFD9014B5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73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7F2AA911-E2FA-4D6D-99EF-A4F7C3E084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D2D9C963-6317-4B2D-9CE1-3741E5E54A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F1E8D7FF-B526-4B0F-A641-6DA91BD2E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9153EB7C-15E3-49AE-948F-8C2AA6CDB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F19A425F-AE89-4FA3-A7C9-C1991630D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340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9219FB64-4885-41A1-9CE3-1062709CD1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838D8C50-AC60-4F58-91DC-C0C3227606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/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B26CBB49-7596-4003-86AD-E5CD211228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/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46995473-5426-4B29-A80B-1A64EFF2E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AE4E9B08-6F15-478C-9DBF-FE462884F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8C54DE3D-84E2-4FBE-A19A-470BE05B8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36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33965922-E2D9-4E83-925A-E126C20A40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55986B76-B7BF-4660-832D-412842244A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78AD4CB8-BB57-47A3-B352-8D97CCF0B7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/>
          </a:p>
        </p:txBody>
      </p:sp>
      <p:sp>
        <p:nvSpPr>
          <p:cNvPr id="5" name="Θέση κειμένου 4">
            <a:extLst>
              <a:ext uri="{FF2B5EF4-FFF2-40B4-BE49-F238E27FC236}">
                <a16:creationId xmlns:a16="http://schemas.microsoft.com/office/drawing/2014/main" id="{68FD20AF-88F1-4C49-BA45-24AC96C9B5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Θέση περιεχομένου 5">
            <a:extLst>
              <a:ext uri="{FF2B5EF4-FFF2-40B4-BE49-F238E27FC236}">
                <a16:creationId xmlns:a16="http://schemas.microsoft.com/office/drawing/2014/main" id="{1CA661D4-44F7-4E4F-A142-A0AB9359D6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/>
          </a:p>
        </p:txBody>
      </p:sp>
      <p:sp>
        <p:nvSpPr>
          <p:cNvPr id="7" name="Θέση ημερομηνίας 6">
            <a:extLst>
              <a:ext uri="{FF2B5EF4-FFF2-40B4-BE49-F238E27FC236}">
                <a16:creationId xmlns:a16="http://schemas.microsoft.com/office/drawing/2014/main" id="{9835E5E4-25E9-4865-A425-5882D99A1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8" name="Θέση υποσέλιδου 7">
            <a:extLst>
              <a:ext uri="{FF2B5EF4-FFF2-40B4-BE49-F238E27FC236}">
                <a16:creationId xmlns:a16="http://schemas.microsoft.com/office/drawing/2014/main" id="{2B3D2273-4DC8-48E8-A927-707071170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Θέση αριθμού διαφάνειας 8">
            <a:extLst>
              <a:ext uri="{FF2B5EF4-FFF2-40B4-BE49-F238E27FC236}">
                <a16:creationId xmlns:a16="http://schemas.microsoft.com/office/drawing/2014/main" id="{915FA35F-4008-4732-8F3E-AE5075497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887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2E7647D9-4895-45BA-8885-1A709D0F0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ημερομηνίας 2">
            <a:extLst>
              <a:ext uri="{FF2B5EF4-FFF2-40B4-BE49-F238E27FC236}">
                <a16:creationId xmlns:a16="http://schemas.microsoft.com/office/drawing/2014/main" id="{7E73D98F-8611-4E9B-BE6A-7EA9E6FF8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4" name="Θέση υποσέλιδου 3">
            <a:extLst>
              <a:ext uri="{FF2B5EF4-FFF2-40B4-BE49-F238E27FC236}">
                <a16:creationId xmlns:a16="http://schemas.microsoft.com/office/drawing/2014/main" id="{81EA3BD1-10BB-416E-9D31-011208BEC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Θέση αριθμού διαφάνειας 4">
            <a:extLst>
              <a:ext uri="{FF2B5EF4-FFF2-40B4-BE49-F238E27FC236}">
                <a16:creationId xmlns:a16="http://schemas.microsoft.com/office/drawing/2014/main" id="{9A7E78FF-1ACC-45FD-AE7D-0D77EA205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323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>
            <a:extLst>
              <a:ext uri="{FF2B5EF4-FFF2-40B4-BE49-F238E27FC236}">
                <a16:creationId xmlns:a16="http://schemas.microsoft.com/office/drawing/2014/main" id="{0232174A-00F8-4471-A439-EFC55D8AD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3" name="Θέση υποσέλιδου 2">
            <a:extLst>
              <a:ext uri="{FF2B5EF4-FFF2-40B4-BE49-F238E27FC236}">
                <a16:creationId xmlns:a16="http://schemas.microsoft.com/office/drawing/2014/main" id="{11E2BFCA-D9C3-4CC8-997B-97887743C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Θέση αριθμού διαφάνειας 3">
            <a:extLst>
              <a:ext uri="{FF2B5EF4-FFF2-40B4-BE49-F238E27FC236}">
                <a16:creationId xmlns:a16="http://schemas.microsoft.com/office/drawing/2014/main" id="{D3BF6221-BC35-4A75-9F47-E6F9A00F5A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20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719F1D29-084F-441E-9E25-21F2E3904F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ED98996B-A10E-479F-9DEF-A67D9B0D52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F55998F3-D57D-4FBE-898C-F944DE70D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2184FD97-2EA3-4BCE-A2FF-7F8ACB3FD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F1FD56D6-2C80-460A-90C8-A0017C0F1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CE9692AB-15F8-4A7C-B31B-996FD4023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78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5244F0D2-9E03-48E6-8659-4B5BD9B6EB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εικόνας 2">
            <a:extLst>
              <a:ext uri="{FF2B5EF4-FFF2-40B4-BE49-F238E27FC236}">
                <a16:creationId xmlns:a16="http://schemas.microsoft.com/office/drawing/2014/main" id="{C7C5685D-9779-455D-919C-577871AA6B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50943271-FFA8-465B-81EF-D880C69AD2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F8BAFD52-CFB5-4D42-A198-3BB1117F7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5CE00CC6-B630-4064-B5DE-3674A41E0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CBB0FFF6-6309-4D37-9F59-952BC4474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470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>
            <a:extLst>
              <a:ext uri="{FF2B5EF4-FFF2-40B4-BE49-F238E27FC236}">
                <a16:creationId xmlns:a16="http://schemas.microsoft.com/office/drawing/2014/main" id="{C1E1C1D8-A398-439D-AA31-684F4E675F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/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3FDA162B-83C2-4582-B3EB-518F6626DF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/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083D1BB-9BFA-49F9-9ABC-94E991B885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DDD54-CAC3-43F5-A668-2D87511D0587}" type="datetimeFigureOut">
              <a:rPr lang="en-US" smtClean="0"/>
              <a:t>8/16/2020</a:t>
            </a:fld>
            <a:endParaRPr lang="en-US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F053F6B7-1729-4F92-AFB2-595857E6DE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8E52A348-EF33-410C-BA4D-C8FE92F2AF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11420-F772-407D-8955-1693359A4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927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Εικόνα 4">
            <a:extLst>
              <a:ext uri="{FF2B5EF4-FFF2-40B4-BE49-F238E27FC236}">
                <a16:creationId xmlns:a16="http://schemas.microsoft.com/office/drawing/2014/main" id="{C8855340-3A85-411D-8E0E-AB1769514E86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06" y="794328"/>
            <a:ext cx="11963588" cy="482258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C0B33FD-6339-47DE-BE74-AECBBBF37EF1}"/>
              </a:ext>
            </a:extLst>
          </p:cNvPr>
          <p:cNvSpPr txBox="1"/>
          <p:nvPr/>
        </p:nvSpPr>
        <p:spPr>
          <a:xfrm>
            <a:off x="228412" y="794328"/>
            <a:ext cx="344243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65096E-2D76-4E54-A28B-F093FB4E2323}"/>
              </a:ext>
            </a:extLst>
          </p:cNvPr>
          <p:cNvSpPr txBox="1"/>
          <p:nvPr/>
        </p:nvSpPr>
        <p:spPr>
          <a:xfrm>
            <a:off x="6735429" y="794328"/>
            <a:ext cx="344243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862891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3B4C2E8-D798-48A4-B907-111B30E1817D}"/>
              </a:ext>
            </a:extLst>
          </p:cNvPr>
          <p:cNvSpPr txBox="1"/>
          <p:nvPr/>
        </p:nvSpPr>
        <p:spPr>
          <a:xfrm>
            <a:off x="192505" y="0"/>
            <a:ext cx="1199949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Figure 1</a:t>
            </a:r>
            <a:endParaRPr lang="en-US" b="1" dirty="0"/>
          </a:p>
          <a:p>
            <a:r>
              <a:rPr lang="en-US" dirty="0"/>
              <a:t>Box-plots of (A) FMD values in the Lp-PLA2 ≥ 125 </a:t>
            </a:r>
            <a:r>
              <a:rPr lang="el-GR" dirty="0"/>
              <a:t>μ</a:t>
            </a:r>
            <a:r>
              <a:rPr lang="en-US" dirty="0"/>
              <a:t>g/L group and Lp-PLA2 &lt; 125 </a:t>
            </a:r>
            <a:r>
              <a:rPr lang="el-GR" dirty="0"/>
              <a:t>μ</a:t>
            </a:r>
            <a:r>
              <a:rPr lang="en-US" dirty="0"/>
              <a:t>g/L group in subjects with stable CAD and (B) Aix values in subjects with Lp-PLA2 ≥ 125 </a:t>
            </a:r>
            <a:r>
              <a:rPr lang="el-GR" dirty="0"/>
              <a:t>μ</a:t>
            </a:r>
            <a:r>
              <a:rPr lang="en-US" dirty="0"/>
              <a:t>g/L compared to subjects with Lp-PLA2 &lt; 125 </a:t>
            </a:r>
            <a:r>
              <a:rPr lang="el-GR" dirty="0"/>
              <a:t>μ</a:t>
            </a:r>
            <a:r>
              <a:rPr lang="en-US" dirty="0"/>
              <a:t>g/L.</a:t>
            </a:r>
          </a:p>
          <a:p>
            <a:r>
              <a:rPr lang="en-US" dirty="0"/>
              <a:t>Lp-PLA2</a:t>
            </a:r>
            <a:r>
              <a:rPr lang="de-DE" dirty="0"/>
              <a:t>: </a:t>
            </a:r>
            <a:r>
              <a:rPr lang="en-US" dirty="0"/>
              <a:t>Lipoprotein-associated phospholipase A2; FMD: flow-mediated dilatation; </a:t>
            </a:r>
            <a:r>
              <a:rPr lang="en-US" dirty="0" err="1"/>
              <a:t>AIx</a:t>
            </a:r>
            <a:r>
              <a:rPr lang="en-US" dirty="0"/>
              <a:t>:  Augmentation Index</a:t>
            </a:r>
            <a:endParaRPr lang="LID4096" dirty="0"/>
          </a:p>
        </p:txBody>
      </p:sp>
    </p:spTree>
    <p:extLst>
      <p:ext uri="{BB962C8B-B14F-4D97-AF65-F5344CB8AC3E}">
        <p14:creationId xmlns:p14="http://schemas.microsoft.com/office/powerpoint/2010/main" val="2559767633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8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Θέμα του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bagelis oikonomou</dc:creator>
  <cp:lastModifiedBy>m9409</cp:lastModifiedBy>
  <cp:revision>8</cp:revision>
  <dcterms:created xsi:type="dcterms:W3CDTF">2019-10-27T06:50:00Z</dcterms:created>
  <dcterms:modified xsi:type="dcterms:W3CDTF">2020-08-16T17:41:48Z</dcterms:modified>
</cp:coreProperties>
</file>